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7" d="100"/>
          <a:sy n="107" d="100"/>
        </p:scale>
        <p:origin x="-8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1983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3288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1631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626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3402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1083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3109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4465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2325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9569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3688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AC7F4-D44A-4EEC-AEDC-1D2225D6572B}" type="datetimeFigureOut">
              <a:rPr lang="ko-KR" altLang="en-US" smtClean="0"/>
              <a:t>2019-05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35EA4-AB56-477D-91FB-43775BD4FFC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2240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1253038" y="476673"/>
            <a:ext cx="2526874" cy="504056"/>
            <a:chOff x="965006" y="476672"/>
            <a:chExt cx="2166834" cy="646331"/>
          </a:xfrm>
        </p:grpSpPr>
        <p:sp>
          <p:nvSpPr>
            <p:cNvPr id="2" name="직사각형 1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965006" y="476672"/>
              <a:ext cx="21602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KNHI cohort enrollees† </a:t>
              </a:r>
              <a:endParaRPr lang="en-US" altLang="ko-KR" sz="1200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1,025,340</a:t>
              </a:r>
              <a:endParaRPr lang="ko-KR" alt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" name="직사각형 6"/>
          <p:cNvSpPr/>
          <p:nvPr/>
        </p:nvSpPr>
        <p:spPr>
          <a:xfrm>
            <a:off x="1259632" y="1196752"/>
            <a:ext cx="2520280" cy="100637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prstClr val="white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56090" y="1205378"/>
            <a:ext cx="253244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4,127 patients who admitted via emergency department due to ischemic stroke (ICD-10, I63 and G45), and  10,605 patients received anticoagulants and antiplatelet agents.</a:t>
            </a:r>
          </a:p>
        </p:txBody>
      </p:sp>
      <p:grpSp>
        <p:nvGrpSpPr>
          <p:cNvPr id="11" name="그룹 10"/>
          <p:cNvGrpSpPr/>
          <p:nvPr/>
        </p:nvGrpSpPr>
        <p:grpSpPr>
          <a:xfrm>
            <a:off x="1259632" y="2780928"/>
            <a:ext cx="2520280" cy="504055"/>
            <a:chOff x="965006" y="476672"/>
            <a:chExt cx="2166834" cy="646331"/>
          </a:xfrm>
        </p:grpSpPr>
        <p:sp>
          <p:nvSpPr>
            <p:cNvPr id="12" name="직사각형 11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65006" y="494172"/>
              <a:ext cx="2160240" cy="591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Initial selection </a:t>
              </a: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9,485</a:t>
              </a:r>
            </a:p>
          </p:txBody>
        </p:sp>
      </p:grpSp>
      <p:grpSp>
        <p:nvGrpSpPr>
          <p:cNvPr id="16" name="그룹 15"/>
          <p:cNvGrpSpPr/>
          <p:nvPr/>
        </p:nvGrpSpPr>
        <p:grpSpPr>
          <a:xfrm>
            <a:off x="1247464" y="3883772"/>
            <a:ext cx="2532447" cy="504055"/>
            <a:chOff x="965006" y="476672"/>
            <a:chExt cx="2166834" cy="646331"/>
          </a:xfrm>
        </p:grpSpPr>
        <p:sp>
          <p:nvSpPr>
            <p:cNvPr id="17" name="직사각형 16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65006" y="511673"/>
              <a:ext cx="2160240" cy="591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Final study sample</a:t>
              </a: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7,693</a:t>
              </a:r>
            </a:p>
          </p:txBody>
        </p:sp>
      </p:grpSp>
      <p:cxnSp>
        <p:nvCxnSpPr>
          <p:cNvPr id="25" name="직선 화살표 연결선 24"/>
          <p:cNvCxnSpPr/>
          <p:nvPr/>
        </p:nvCxnSpPr>
        <p:spPr>
          <a:xfrm>
            <a:off x="2483768" y="2204864"/>
            <a:ext cx="0" cy="6074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/>
          <p:cNvCxnSpPr/>
          <p:nvPr/>
        </p:nvCxnSpPr>
        <p:spPr>
          <a:xfrm>
            <a:off x="2474715" y="3284984"/>
            <a:ext cx="0" cy="6074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화살표 연결선 21"/>
          <p:cNvCxnSpPr/>
          <p:nvPr/>
        </p:nvCxnSpPr>
        <p:spPr>
          <a:xfrm flipH="1">
            <a:off x="2483352" y="3577633"/>
            <a:ext cx="189421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971600" y="4726885"/>
            <a:ext cx="7632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bbreviations: KNHI, Korean National Health Insurance; </a:t>
            </a:r>
          </a:p>
          <a:p>
            <a:pPr algn="just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†, the Korean National Health Insurance, this </a:t>
            </a:r>
            <a:r>
              <a:rPr lang="en-US" altLang="ko-KR" sz="1200" dirty="0">
                <a:solidFill>
                  <a:prstClr val="black"/>
                </a:solidFill>
                <a:latin typeface="Times New Roman"/>
              </a:rPr>
              <a:t>is an universal health insurance plan that covers almost all the population and medical facilities. </a:t>
            </a:r>
            <a:endParaRPr lang="en-US" altLang="ko-KR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691680" y="5949656"/>
            <a:ext cx="56166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Supplemental Figure</a:t>
            </a:r>
            <a:r>
              <a:rPr lang="ko-KR" altLang="en-US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. Selection flowchart of patient with ischemic stroke </a:t>
            </a:r>
            <a:endParaRPr lang="ko-KR" altLang="en-US" sz="1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27984" y="3308791"/>
            <a:ext cx="33843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xcluding : total 1,792 patients were excluded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,135 patients who were transferred to another hospital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642 patients who used long-term care facilities, hospitals and clinics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5 patients who were less than 20-year old.</a:t>
            </a:r>
          </a:p>
        </p:txBody>
      </p:sp>
    </p:spTree>
    <p:extLst>
      <p:ext uri="{BB962C8B-B14F-4D97-AF65-F5344CB8AC3E}">
        <p14:creationId xmlns:p14="http://schemas.microsoft.com/office/powerpoint/2010/main" val="42273807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1253038" y="476672"/>
            <a:ext cx="2526874" cy="646331"/>
            <a:chOff x="965006" y="476672"/>
            <a:chExt cx="2166834" cy="646331"/>
          </a:xfrm>
        </p:grpSpPr>
        <p:sp>
          <p:nvSpPr>
            <p:cNvPr id="2" name="직사각형 1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965006" y="476672"/>
              <a:ext cx="216024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Stratified</a:t>
              </a:r>
              <a:r>
                <a:rPr lang="ko-KR" altLang="en-U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Random Sample of 2002 KNHI enrollees† </a:t>
              </a:r>
              <a:endParaRPr lang="en-US" altLang="ko-KR" sz="1200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1,025,340</a:t>
              </a:r>
              <a:endParaRPr lang="ko-KR" alt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" name="직사각형 6"/>
          <p:cNvSpPr/>
          <p:nvPr/>
        </p:nvSpPr>
        <p:spPr>
          <a:xfrm>
            <a:off x="1259632" y="1340768"/>
            <a:ext cx="2520280" cy="14570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prstClr val="white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67302" y="1469104"/>
            <a:ext cx="2532448" cy="1200329"/>
          </a:xfrm>
          <a:prstGeom prst="rect">
            <a:avLst/>
          </a:prstGeom>
          <a:noFill/>
          <a:ln>
            <a:noFill/>
            <a:prstDash val="solid"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4,405 patients who admitted via emergency department due to </a:t>
            </a:r>
            <a:r>
              <a:rPr lang="en-US" altLang="ko-KR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Hemorrhagic stroke (ICD-10</a:t>
            </a: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 I60, I61 and I62), and 3,662 patients received intravenous antihypertensive agents, Mannitol or craniotomy.</a:t>
            </a:r>
          </a:p>
        </p:txBody>
      </p:sp>
      <p:grpSp>
        <p:nvGrpSpPr>
          <p:cNvPr id="11" name="그룹 10"/>
          <p:cNvGrpSpPr/>
          <p:nvPr/>
        </p:nvGrpSpPr>
        <p:grpSpPr>
          <a:xfrm>
            <a:off x="1259632" y="2996952"/>
            <a:ext cx="2520280" cy="504055"/>
            <a:chOff x="965006" y="476672"/>
            <a:chExt cx="2166834" cy="646331"/>
          </a:xfrm>
        </p:grpSpPr>
        <p:sp>
          <p:nvSpPr>
            <p:cNvPr id="12" name="직사각형 11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65006" y="494172"/>
              <a:ext cx="2160240" cy="591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Initial selection </a:t>
              </a: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3,662</a:t>
              </a:r>
            </a:p>
          </p:txBody>
        </p:sp>
      </p:grpSp>
      <p:grpSp>
        <p:nvGrpSpPr>
          <p:cNvPr id="16" name="그룹 15"/>
          <p:cNvGrpSpPr/>
          <p:nvPr/>
        </p:nvGrpSpPr>
        <p:grpSpPr>
          <a:xfrm>
            <a:off x="1247464" y="4099796"/>
            <a:ext cx="2532447" cy="504055"/>
            <a:chOff x="965006" y="476672"/>
            <a:chExt cx="2166834" cy="646331"/>
          </a:xfrm>
        </p:grpSpPr>
        <p:sp>
          <p:nvSpPr>
            <p:cNvPr id="17" name="직사각형 16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65006" y="511673"/>
              <a:ext cx="2160240" cy="591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Final study sample</a:t>
              </a: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2,828</a:t>
              </a:r>
            </a:p>
          </p:txBody>
        </p:sp>
      </p:grpSp>
      <p:cxnSp>
        <p:nvCxnSpPr>
          <p:cNvPr id="20" name="직선 화살표 연결선 19"/>
          <p:cNvCxnSpPr>
            <a:endCxn id="8" idx="0"/>
          </p:cNvCxnSpPr>
          <p:nvPr/>
        </p:nvCxnSpPr>
        <p:spPr>
          <a:xfrm flipH="1">
            <a:off x="2533526" y="1467363"/>
            <a:ext cx="6632" cy="174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/>
          <p:cNvCxnSpPr/>
          <p:nvPr/>
        </p:nvCxnSpPr>
        <p:spPr>
          <a:xfrm>
            <a:off x="2474715" y="3501008"/>
            <a:ext cx="0" cy="6074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화살표 연결선 21"/>
          <p:cNvCxnSpPr/>
          <p:nvPr/>
        </p:nvCxnSpPr>
        <p:spPr>
          <a:xfrm flipH="1">
            <a:off x="2483352" y="3793657"/>
            <a:ext cx="189421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971600" y="5158933"/>
            <a:ext cx="7632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bbreviations: KNHI, Korean National Health Insurance; </a:t>
            </a:r>
          </a:p>
          <a:p>
            <a:pPr algn="just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†, the Korean National Health Insurance, this </a:t>
            </a:r>
            <a:r>
              <a:rPr lang="en-US" altLang="ko-KR" sz="1200" dirty="0">
                <a:solidFill>
                  <a:prstClr val="black"/>
                </a:solidFill>
                <a:latin typeface="Times New Roman"/>
              </a:rPr>
              <a:t>is an universal health insurance plan that covers almost all the population and medical facilities. </a:t>
            </a:r>
            <a:endParaRPr lang="en-US" altLang="ko-KR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60728" y="5949656"/>
            <a:ext cx="6047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l Figure</a:t>
            </a:r>
            <a:r>
              <a:rPr lang="ko-KR" altLang="en-US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election flowchart of patient with hemorrhagic stroke </a:t>
            </a:r>
            <a:endParaRPr lang="ko-KR" altLang="en-US" sz="1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27984" y="3443516"/>
            <a:ext cx="33843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xcluding: total  834patients were excluded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701 patients who were transferred to another hospital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8  patients who used long-term care facilities, hospitals and clinics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5 patients who were less than 20-year old.</a:t>
            </a:r>
          </a:p>
        </p:txBody>
      </p:sp>
      <p:cxnSp>
        <p:nvCxnSpPr>
          <p:cNvPr id="14" name="직선 화살표 연결선 13"/>
          <p:cNvCxnSpPr/>
          <p:nvPr/>
        </p:nvCxnSpPr>
        <p:spPr>
          <a:xfrm>
            <a:off x="2483768" y="1123003"/>
            <a:ext cx="0" cy="21776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화살표 연결선 22"/>
          <p:cNvCxnSpPr/>
          <p:nvPr/>
        </p:nvCxnSpPr>
        <p:spPr>
          <a:xfrm>
            <a:off x="2483768" y="2779187"/>
            <a:ext cx="0" cy="21776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23633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1253038" y="476672"/>
            <a:ext cx="2526874" cy="646331"/>
            <a:chOff x="965006" y="476672"/>
            <a:chExt cx="2166834" cy="646331"/>
          </a:xfrm>
        </p:grpSpPr>
        <p:sp>
          <p:nvSpPr>
            <p:cNvPr id="2" name="직사각형 1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965006" y="476672"/>
              <a:ext cx="216024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Stratified</a:t>
              </a:r>
              <a:r>
                <a:rPr lang="ko-KR" altLang="en-U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Random Sample of 2002 KNHI enrollees† </a:t>
              </a:r>
              <a:endParaRPr lang="en-US" altLang="ko-KR" sz="1200" baseline="30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1,025,340</a:t>
              </a:r>
              <a:endParaRPr lang="ko-KR" altLang="en-US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" name="직사각형 6"/>
          <p:cNvSpPr/>
          <p:nvPr/>
        </p:nvSpPr>
        <p:spPr>
          <a:xfrm>
            <a:off x="1259632" y="1556791"/>
            <a:ext cx="252028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prstClr val="white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247464" y="1556792"/>
            <a:ext cx="25324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6,575patients who admitted via emergency department due to </a:t>
            </a:r>
            <a:r>
              <a:rPr lang="en-US" altLang="ko-KR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cute myocardial infarction (ICD-10</a:t>
            </a: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; I21, I22 and I25.2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427984" y="2492896"/>
            <a:ext cx="38730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xcluding: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614 did not receive aspirin.</a:t>
            </a:r>
            <a:endParaRPr lang="ko-KR" alt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1259632" y="2996952"/>
            <a:ext cx="2520280" cy="504055"/>
            <a:chOff x="965006" y="476672"/>
            <a:chExt cx="2166834" cy="646331"/>
          </a:xfrm>
        </p:grpSpPr>
        <p:sp>
          <p:nvSpPr>
            <p:cNvPr id="12" name="직사각형 11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965006" y="494172"/>
              <a:ext cx="2160240" cy="591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Initial selection </a:t>
              </a: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5,961</a:t>
              </a:r>
            </a:p>
          </p:txBody>
        </p:sp>
      </p:grpSp>
      <p:grpSp>
        <p:nvGrpSpPr>
          <p:cNvPr id="16" name="그룹 15"/>
          <p:cNvGrpSpPr/>
          <p:nvPr/>
        </p:nvGrpSpPr>
        <p:grpSpPr>
          <a:xfrm>
            <a:off x="1247464" y="4099796"/>
            <a:ext cx="2532447" cy="504055"/>
            <a:chOff x="965006" y="476672"/>
            <a:chExt cx="2166834" cy="646331"/>
          </a:xfrm>
        </p:grpSpPr>
        <p:sp>
          <p:nvSpPr>
            <p:cNvPr id="17" name="직사각형 16"/>
            <p:cNvSpPr/>
            <p:nvPr/>
          </p:nvSpPr>
          <p:spPr>
            <a:xfrm>
              <a:off x="971600" y="476672"/>
              <a:ext cx="2160240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prstClr val="white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65006" y="511673"/>
              <a:ext cx="2160240" cy="591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Final study sample</a:t>
              </a:r>
            </a:p>
            <a:p>
              <a:pPr algn="ctr"/>
              <a:r>
                <a:rPr lang="en-US" altLang="ko-KR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N=4,916</a:t>
              </a:r>
            </a:p>
          </p:txBody>
        </p:sp>
      </p:grpSp>
      <p:cxnSp>
        <p:nvCxnSpPr>
          <p:cNvPr id="20" name="직선 화살표 연결선 19"/>
          <p:cNvCxnSpPr>
            <a:stCxn id="2" idx="2"/>
            <a:endCxn id="8" idx="0"/>
          </p:cNvCxnSpPr>
          <p:nvPr/>
        </p:nvCxnSpPr>
        <p:spPr>
          <a:xfrm flipH="1">
            <a:off x="2513688" y="1123003"/>
            <a:ext cx="6632" cy="43378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화살표 연결선 24"/>
          <p:cNvCxnSpPr/>
          <p:nvPr/>
        </p:nvCxnSpPr>
        <p:spPr>
          <a:xfrm>
            <a:off x="2483768" y="2420888"/>
            <a:ext cx="0" cy="6074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/>
          <p:cNvCxnSpPr/>
          <p:nvPr/>
        </p:nvCxnSpPr>
        <p:spPr>
          <a:xfrm>
            <a:off x="2474715" y="3501008"/>
            <a:ext cx="0" cy="6074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화살표 연결선 21"/>
          <p:cNvCxnSpPr/>
          <p:nvPr/>
        </p:nvCxnSpPr>
        <p:spPr>
          <a:xfrm flipH="1">
            <a:off x="2483352" y="3793657"/>
            <a:ext cx="189421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971600" y="5158933"/>
            <a:ext cx="7632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bbreviations: KNHI, Korean National Health Insurance; </a:t>
            </a:r>
          </a:p>
          <a:p>
            <a:pPr algn="just"/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†, the Korean National Health Insurance, this </a:t>
            </a:r>
            <a:r>
              <a:rPr lang="en-US" altLang="ko-KR" sz="1200" dirty="0">
                <a:solidFill>
                  <a:prstClr val="black"/>
                </a:solidFill>
                <a:latin typeface="Times New Roman"/>
              </a:rPr>
              <a:t>is an universal health insurance plan that covers almost all the population and medical facilities. </a:t>
            </a:r>
            <a:endParaRPr lang="en-US" altLang="ko-KR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115616" y="5949656"/>
            <a:ext cx="6840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l Figure</a:t>
            </a:r>
            <a:r>
              <a:rPr lang="ko-KR" altLang="en-US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3. Selection </a:t>
            </a:r>
            <a:r>
              <a:rPr lang="en-US" altLang="ko-KR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lowchart of patient with acute myocardial infarction </a:t>
            </a:r>
            <a:endParaRPr lang="ko-KR" altLang="en-US" sz="14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27984" y="3443516"/>
            <a:ext cx="338437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xcluding: total  1,045patients were excluded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400 patients who were not by performed cardiac enzyme test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514 patients who were transferred to another hospital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122  patients who used long-term care facilities, hospitals and clinics.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US" altLang="ko-KR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9 patients who were less than 20-year old.</a:t>
            </a:r>
          </a:p>
        </p:txBody>
      </p:sp>
      <p:cxnSp>
        <p:nvCxnSpPr>
          <p:cNvPr id="26" name="직선 화살표 연결선 25"/>
          <p:cNvCxnSpPr/>
          <p:nvPr/>
        </p:nvCxnSpPr>
        <p:spPr>
          <a:xfrm flipH="1">
            <a:off x="2509834" y="2724600"/>
            <a:ext cx="186773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86826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86</Words>
  <Application>Microsoft Office PowerPoint</Application>
  <PresentationFormat>On-screen Show (4:3)</PresentationFormat>
  <Paragraphs>4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테마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amsung</dc:creator>
  <cp:lastModifiedBy>74639</cp:lastModifiedBy>
  <cp:revision>1</cp:revision>
  <dcterms:created xsi:type="dcterms:W3CDTF">2018-03-09T05:38:04Z</dcterms:created>
  <dcterms:modified xsi:type="dcterms:W3CDTF">2019-05-15T18:59:40Z</dcterms:modified>
</cp:coreProperties>
</file>